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368" r:id="rId2"/>
  </p:sldIdLst>
  <p:sldSz cx="7559675" cy="1069181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6C0A"/>
    <a:srgbClr val="77933C"/>
    <a:srgbClr val="F070B3"/>
    <a:srgbClr val="A9D18E"/>
    <a:srgbClr val="F23EDD"/>
    <a:srgbClr val="01B601"/>
    <a:srgbClr val="FF6200"/>
    <a:srgbClr val="FFD8BE"/>
    <a:srgbClr val="00B72E"/>
    <a:srgbClr val="00BF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65" autoAdjust="0"/>
    <p:restoredTop sz="95220" autoAdjust="0"/>
  </p:normalViewPr>
  <p:slideViewPr>
    <p:cSldViewPr snapToGrid="0">
      <p:cViewPr>
        <p:scale>
          <a:sx n="75" d="100"/>
          <a:sy n="75" d="100"/>
        </p:scale>
        <p:origin x="2208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-&#24037;&#20316;1\2-&#22312;&#30740;&#39033;&#30446;\2-NO%20and%20Gdpd2\66-Figure\Figure&#29992;&#22270;\Figure2\20200602-25&#956;m%20DEA%20NONOate&#23545;Mlg&#29983;&#38271;&#30340;&#24433;&#21709;\0200606-25&#956;m%20DEA%20NONOate&#23545;Mlg&#29983;&#38271;&#30340;&#24433;&#21709;&#20010;&#25968;&#32479;&#35745;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1-&#24037;&#20316;1\2-&#22312;&#30740;&#39033;&#30446;\2-NO%20and%20Gdpd2\66-Figure\Figure&#29992;&#22270;\Figure2\20200602-25&#956;m%20DEA%20NONOate&#23545;Mlg&#29983;&#38271;&#30340;&#24433;&#21709;\0200606-25&#956;m%20DEA%20NONOate&#23545;Mlg&#29983;&#38271;&#30340;&#24433;&#21709;-qPCR.xls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-&#24037;&#20316;1\2-&#22312;&#30740;&#39033;&#30446;\2-NO%20and%20Gdpd2\66-Figure\Figure&#29992;&#22270;\Figure2\20200602-25&#956;m%20DEA%20NONOate&#23545;Mlg&#29983;&#38271;&#30340;&#24433;&#21709;\0200606-25&#956;m%20DEA%20NONOate&#23545;Mlg&#29983;&#38271;&#30340;&#24433;&#21709;-qPCR.xls" TargetMode="External"/><Relationship Id="rId1" Type="http://schemas.openxmlformats.org/officeDocument/2006/relationships/themeOverride" Target="../theme/themeOverride2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D:\1-&#24037;&#20316;1\2-&#22312;&#30740;&#39033;&#30446;\2-NO%20and%20Gdpd2\66-Figure\Figure&#29992;&#22270;\Figure2\20200602-25&#956;m%20DEA%20NONOate&#23545;Mlg&#29983;&#38271;&#30340;&#24433;&#21709;\0200606-25&#956;m%20DEA%20NONOate&#23545;Mlg&#29983;&#38271;&#30340;&#24433;&#21709;-qPCR.xls" TargetMode="External"/><Relationship Id="rId1" Type="http://schemas.openxmlformats.org/officeDocument/2006/relationships/themeOverride" Target="../theme/themeOverrid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E:\2-NO\NO\&#20811;&#38534;\20190621-Club-DEA%20NONOate-3D&#20811;&#38534;-&#26041;&#24046;&#20998;&#26512;-&#24050;&#29992;\&#19981;&#21516;&#27987;&#24230;NO&#20811;&#38534;&#30452;&#24452;&#32479;&#35745;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E:\2-NO\NO\&#20811;&#38534;\20190621-Club-DEA%20NONOate-3D&#20811;&#38534;-&#26041;&#24046;&#20998;&#26512;-&#24050;&#29992;\&#19981;&#21516;&#27987;&#24230;NO&#20811;&#38534;&#30452;&#24452;&#32479;&#35745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9050">
              <a:solidFill>
                <a:srgbClr val="E46C0A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rgbClr val="77933C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B6A-4330-A32F-27381D297446}"/>
              </c:ext>
            </c:extLst>
          </c:dPt>
          <c:errBars>
            <c:errBarType val="plus"/>
            <c:errValType val="cust"/>
            <c:noEndCap val="0"/>
            <c:plus>
              <c:numRef>
                <c:f>mlg计数!$I$5:$I$6</c:f>
                <c:numCache>
                  <c:formatCode>General</c:formatCode>
                  <c:ptCount val="2"/>
                  <c:pt idx="0">
                    <c:v>56457.948953181076</c:v>
                  </c:pt>
                  <c:pt idx="1">
                    <c:v>80104.098937986011</c:v>
                  </c:pt>
                </c:numCache>
              </c:numRef>
            </c:plus>
            <c:spPr>
              <a:noFill/>
              <a:ln w="19050">
                <a:solidFill>
                  <a:schemeClr val="tx1"/>
                </a:solidFill>
              </a:ln>
              <a:effectLst/>
            </c:spPr>
          </c:errBars>
          <c:cat>
            <c:strRef>
              <c:f>mlg计数!$H$2:$H$3</c:f>
              <c:strCache>
                <c:ptCount val="2"/>
                <c:pt idx="0">
                  <c:v>CTL</c:v>
                </c:pt>
                <c:pt idx="1">
                  <c:v>DEA NONOate 25μM</c:v>
                </c:pt>
              </c:strCache>
            </c:strRef>
          </c:cat>
          <c:val>
            <c:numRef>
              <c:f>mlg计数!$I$2:$I$3</c:f>
              <c:numCache>
                <c:formatCode>0</c:formatCode>
                <c:ptCount val="2"/>
                <c:pt idx="0">
                  <c:v>412500</c:v>
                </c:pt>
                <c:pt idx="1">
                  <c:v>441666.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B6A-4330-A32F-27381D2974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89853679"/>
        <c:axId val="1"/>
      </c:barChart>
      <c:catAx>
        <c:axId val="58985367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zh-CN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in val="0"/>
        </c:scaling>
        <c:delete val="0"/>
        <c:axPos val="l"/>
        <c:numFmt formatCode="0E+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zh-CN"/>
          </a:p>
        </c:txPr>
        <c:crossAx val="589853679"/>
        <c:crosses val="autoZero"/>
        <c:crossBetween val="between"/>
        <c:majorUnit val="20000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6350">
      <a:noFill/>
    </a:ln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428571428571427"/>
          <c:y val="4.2553191489361701E-2"/>
          <c:w val="0.56342777777777775"/>
          <c:h val="0.72948328267477203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 w="19050">
              <a:solidFill>
                <a:srgbClr val="E46C0A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rgbClr val="77933C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9DE0-4D12-9EBD-FD0DC21CA6C9}"/>
              </c:ext>
            </c:extLst>
          </c:dPt>
          <c:errBars>
            <c:errBarType val="plus"/>
            <c:errValType val="cust"/>
            <c:noEndCap val="0"/>
            <c:plus>
              <c:numRef>
                <c:f>'Analysis-Club-b-actin'!$C$18:$C$19</c:f>
                <c:numCache>
                  <c:formatCode>General</c:formatCode>
                  <c:ptCount val="2"/>
                  <c:pt idx="0">
                    <c:v>4.6561547578663478E-3</c:v>
                  </c:pt>
                  <c:pt idx="1">
                    <c:v>2.2622080705344497E-3</c:v>
                  </c:pt>
                </c:numCache>
              </c:numRef>
            </c:plus>
            <c:spPr>
              <a:noFill/>
              <a:ln w="19050">
                <a:solidFill>
                  <a:schemeClr val="tx1"/>
                </a:solidFill>
              </a:ln>
            </c:spPr>
          </c:errBars>
          <c:cat>
            <c:strRef>
              <c:f>'Analysis-Club-b-actin'!$B$15:$B$16</c:f>
              <c:strCache>
                <c:ptCount val="2"/>
                <c:pt idx="0">
                  <c:v>CTL</c:v>
                </c:pt>
                <c:pt idx="1">
                  <c:v>DEA NONOate 25μM</c:v>
                </c:pt>
              </c:strCache>
            </c:strRef>
          </c:cat>
          <c:val>
            <c:numRef>
              <c:f>'Analysis-Club-b-actin'!$C$15:$C$16</c:f>
              <c:numCache>
                <c:formatCode>General</c:formatCode>
                <c:ptCount val="2"/>
                <c:pt idx="0">
                  <c:v>9.2445418612519762E-3</c:v>
                </c:pt>
                <c:pt idx="1">
                  <c:v>8.422755344968032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DE0-4D12-9EBD-FD0DC21CA6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73939343"/>
        <c:axId val="1"/>
      </c:barChart>
      <c:catAx>
        <c:axId val="37393934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 w="19050">
            <a:solidFill>
              <a:schemeClr val="tx1"/>
            </a:solidFill>
          </a:ln>
        </c:sp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373939343"/>
        <c:crosses val="autoZero"/>
        <c:crossBetween val="between"/>
        <c:majorUnit val="5.000000000000001E-3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7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465116279069767"/>
          <c:y val="4.72972972972973E-2"/>
          <c:w val="0.55764062500000011"/>
          <c:h val="0.69932432432432434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 w="19050">
              <a:solidFill>
                <a:srgbClr val="E46C0A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rgbClr val="77933C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B67-4879-B1D5-526AFED163B9}"/>
              </c:ext>
            </c:extLst>
          </c:dPt>
          <c:errBars>
            <c:errBarType val="plus"/>
            <c:errValType val="cust"/>
            <c:noEndCap val="0"/>
            <c:plus>
              <c:numRef>
                <c:f>'Analysis-Club-b-actin'!$X$18:$X$19</c:f>
                <c:numCache>
                  <c:formatCode>General</c:formatCode>
                  <c:ptCount val="2"/>
                  <c:pt idx="0">
                    <c:v>3.0454134634006862E-3</c:v>
                  </c:pt>
                  <c:pt idx="1">
                    <c:v>6.6578800953165308E-4</c:v>
                  </c:pt>
                </c:numCache>
              </c:numRef>
            </c:plus>
            <c:spPr>
              <a:noFill/>
              <a:ln w="19050">
                <a:solidFill>
                  <a:schemeClr val="tx1"/>
                </a:solidFill>
              </a:ln>
            </c:spPr>
          </c:errBars>
          <c:cat>
            <c:strRef>
              <c:f>'Analysis-Club-b-actin'!$W$15:$W$16</c:f>
              <c:strCache>
                <c:ptCount val="2"/>
                <c:pt idx="0">
                  <c:v>CTL</c:v>
                </c:pt>
                <c:pt idx="1">
                  <c:v>DEA NONOate 25μM</c:v>
                </c:pt>
              </c:strCache>
            </c:strRef>
          </c:cat>
          <c:val>
            <c:numRef>
              <c:f>'Analysis-Club-b-actin'!$X$15:$X$16</c:f>
              <c:numCache>
                <c:formatCode>General</c:formatCode>
                <c:ptCount val="2"/>
                <c:pt idx="0">
                  <c:v>6.9949596297471271E-3</c:v>
                </c:pt>
                <c:pt idx="1">
                  <c:v>6.906116417940644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B67-4879-B1D5-526AFED163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73951823"/>
        <c:axId val="1"/>
      </c:barChart>
      <c:catAx>
        <c:axId val="37395182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 w="19050">
            <a:solidFill>
              <a:schemeClr val="tx1"/>
            </a:solidFill>
          </a:ln>
        </c:sp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373951823"/>
        <c:crosses val="autoZero"/>
        <c:crossBetween val="between"/>
        <c:minorUnit val="3.0000000000000009E-3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7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9050">
              <a:solidFill>
                <a:srgbClr val="E46C0A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rgbClr val="77933C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A55-4208-96F4-CFF441D75C3D}"/>
              </c:ext>
            </c:extLst>
          </c:dPt>
          <c:errBars>
            <c:errBarType val="plus"/>
            <c:errValType val="cust"/>
            <c:noEndCap val="0"/>
            <c:plus>
              <c:numRef>
                <c:f>'Analysis-Club-b-actin'!$AE$18:$AE$19</c:f>
                <c:numCache>
                  <c:formatCode>General</c:formatCode>
                  <c:ptCount val="2"/>
                  <c:pt idx="0">
                    <c:v>3.074500472089986E-3</c:v>
                  </c:pt>
                  <c:pt idx="1">
                    <c:v>1.2031509249118863E-3</c:v>
                  </c:pt>
                </c:numCache>
              </c:numRef>
            </c:plus>
            <c:spPr>
              <a:noFill/>
              <a:ln w="19050">
                <a:solidFill>
                  <a:schemeClr val="tx1"/>
                </a:solidFill>
              </a:ln>
              <a:effectLst/>
            </c:spPr>
          </c:errBars>
          <c:cat>
            <c:strRef>
              <c:f>'Analysis-Club-b-actin'!$AD$15:$AD$16</c:f>
              <c:strCache>
                <c:ptCount val="2"/>
                <c:pt idx="0">
                  <c:v>CTL</c:v>
                </c:pt>
                <c:pt idx="1">
                  <c:v>DEA NONOate 25μM</c:v>
                </c:pt>
              </c:strCache>
            </c:strRef>
          </c:cat>
          <c:val>
            <c:numRef>
              <c:f>'Analysis-Club-b-actin'!$AE$15:$AE$16</c:f>
              <c:numCache>
                <c:formatCode>General</c:formatCode>
                <c:ptCount val="2"/>
                <c:pt idx="0">
                  <c:v>5.696792382277111E-3</c:v>
                </c:pt>
                <c:pt idx="1">
                  <c:v>4.400547201412221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A55-4208-96F4-CFF441D75C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73943919"/>
        <c:axId val="1"/>
      </c:barChart>
      <c:catAx>
        <c:axId val="37394391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zh-CN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zh-CN"/>
          </a:p>
        </c:txPr>
        <c:crossAx val="373943919"/>
        <c:crosses val="autoZero"/>
        <c:crossBetween val="between"/>
        <c:majorUnit val="4.000000000000001E-3"/>
        <c:minorUnit val="5.0000000000000012E-4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6350">
      <a:noFill/>
    </a:ln>
  </c:spPr>
  <c:txPr>
    <a:bodyPr/>
    <a:lstStyle/>
    <a:p>
      <a:pPr>
        <a:defRPr sz="7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9050">
              <a:solidFill>
                <a:schemeClr val="accent3">
                  <a:lumMod val="75000"/>
                </a:schemeClr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noFill/>
              <a:ln w="19050">
                <a:solidFill>
                  <a:schemeClr val="accent6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04A-46A9-AA6A-E68CB9BCF748}"/>
              </c:ext>
            </c:extLst>
          </c:dPt>
          <c:dPt>
            <c:idx val="2"/>
            <c:invertIfNegative val="0"/>
            <c:bubble3D val="0"/>
            <c:spPr>
              <a:noFill/>
              <a:ln w="19050">
                <a:solidFill>
                  <a:schemeClr val="accent6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04A-46A9-AA6A-E68CB9BCF748}"/>
              </c:ext>
            </c:extLst>
          </c:dPt>
          <c:dPt>
            <c:idx val="3"/>
            <c:invertIfNegative val="0"/>
            <c:bubble3D val="0"/>
            <c:spPr>
              <a:noFill/>
              <a:ln w="19050">
                <a:solidFill>
                  <a:schemeClr val="accent2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04A-46A9-AA6A-E68CB9BCF748}"/>
              </c:ext>
            </c:extLst>
          </c:dPt>
          <c:errBars>
            <c:errBarType val="plus"/>
            <c:errValType val="cust"/>
            <c:noEndCap val="0"/>
            <c:plus>
              <c:numRef>
                <c:f>'club-dia&gt;50.150um-analysis-留25'!$C$24:$C$26</c:f>
                <c:numCache>
                  <c:formatCode>General</c:formatCode>
                  <c:ptCount val="3"/>
                  <c:pt idx="0">
                    <c:v>10.640912316406608</c:v>
                  </c:pt>
                  <c:pt idx="1">
                    <c:v>6.22580549861748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club-dia&gt;50.150um-analysis-留25'!$A$24:$A$25</c:f>
              <c:strCache>
                <c:ptCount val="2"/>
                <c:pt idx="0">
                  <c:v>Control</c:v>
                </c:pt>
                <c:pt idx="1">
                  <c:v>DEA NONOate 25μM</c:v>
                </c:pt>
              </c:strCache>
            </c:strRef>
          </c:cat>
          <c:val>
            <c:numRef>
              <c:f>'club-dia&gt;50.150um-analysis-留25'!$B$24:$B$25</c:f>
              <c:numCache>
                <c:formatCode>General</c:formatCode>
                <c:ptCount val="2"/>
                <c:pt idx="0">
                  <c:v>159.20241950574879</c:v>
                </c:pt>
                <c:pt idx="1">
                  <c:v>90.7699857637111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04A-46A9-AA6A-E68CB9BCF7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23349976"/>
        <c:axId val="523342136"/>
      </c:barChart>
      <c:catAx>
        <c:axId val="5233499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23342136"/>
        <c:crosses val="autoZero"/>
        <c:auto val="1"/>
        <c:lblAlgn val="ctr"/>
        <c:lblOffset val="100"/>
        <c:noMultiLvlLbl val="0"/>
      </c:catAx>
      <c:valAx>
        <c:axId val="523342136"/>
        <c:scaling>
          <c:orientation val="minMax"/>
          <c:max val="2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2334997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9050">
              <a:solidFill>
                <a:schemeClr val="accent3">
                  <a:lumMod val="75000"/>
                </a:schemeClr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noFill/>
              <a:ln w="19050">
                <a:solidFill>
                  <a:schemeClr val="accent6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C42-4E34-BB41-E825A8BBB933}"/>
              </c:ext>
            </c:extLst>
          </c:dPt>
          <c:dPt>
            <c:idx val="2"/>
            <c:invertIfNegative val="0"/>
            <c:bubble3D val="0"/>
            <c:spPr>
              <a:noFill/>
              <a:ln w="19050">
                <a:solidFill>
                  <a:schemeClr val="accent6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C42-4E34-BB41-E825A8BBB933}"/>
              </c:ext>
            </c:extLst>
          </c:dPt>
          <c:dPt>
            <c:idx val="3"/>
            <c:invertIfNegative val="0"/>
            <c:bubble3D val="0"/>
            <c:spPr>
              <a:noFill/>
              <a:ln w="19050">
                <a:solidFill>
                  <a:schemeClr val="accent2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C42-4E34-BB41-E825A8BBB933}"/>
              </c:ext>
            </c:extLst>
          </c:dPt>
          <c:errBars>
            <c:errBarType val="plus"/>
            <c:errValType val="cust"/>
            <c:noEndCap val="0"/>
            <c:plus>
              <c:numRef>
                <c:f>'club-dia&gt;50.150um-analysis-留25'!$J$24:$J$27</c:f>
                <c:numCache>
                  <c:formatCode>General</c:formatCode>
                  <c:ptCount val="4"/>
                  <c:pt idx="0">
                    <c:v>0.42529989419232173</c:v>
                  </c:pt>
                  <c:pt idx="1">
                    <c:v>0.70071392165419399</c:v>
                  </c:pt>
                  <c:pt idx="2">
                    <c:v>0.48443781850718476</c:v>
                  </c:pt>
                  <c:pt idx="3">
                    <c:v>0.396383652538799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club-dia&gt;50.150um-analysis-留25'!$N$24:$N$25</c:f>
              <c:strCache>
                <c:ptCount val="2"/>
                <c:pt idx="0">
                  <c:v>Control</c:v>
                </c:pt>
                <c:pt idx="1">
                  <c:v>DEA NONOate 25μM</c:v>
                </c:pt>
              </c:strCache>
            </c:strRef>
          </c:cat>
          <c:val>
            <c:numRef>
              <c:f>'club-dia&gt;50.150um-analysis-留25'!$O$24:$O$25</c:f>
              <c:numCache>
                <c:formatCode>General</c:formatCode>
                <c:ptCount val="2"/>
                <c:pt idx="0">
                  <c:v>2.5880000000000001</c:v>
                </c:pt>
                <c:pt idx="1">
                  <c:v>0.5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C42-4E34-BB41-E825A8BBB9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23342920"/>
        <c:axId val="523349192"/>
      </c:barChart>
      <c:catAx>
        <c:axId val="5233429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23349192"/>
        <c:crosses val="autoZero"/>
        <c:auto val="1"/>
        <c:lblAlgn val="ctr"/>
        <c:lblOffset val="100"/>
        <c:noMultiLvlLbl val="0"/>
      </c:catAx>
      <c:valAx>
        <c:axId val="5233491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2334292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B29721-A363-4FA3-9E2C-56891A475333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F2F335-5CFE-4E61-B7FF-9AF214C2F7E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F2F335-5CFE-4E61-B7FF-9AF214C2F7E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34683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7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80"/>
            <a:ext cx="5669756" cy="2581379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5650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89760" indent="0" algn="ctr">
              <a:buNone/>
              <a:defRPr sz="1325"/>
            </a:lvl6pPr>
            <a:lvl7pPr marL="2267585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3870" indent="0" algn="ctr">
              <a:buNone/>
              <a:defRPr sz="132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2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2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5"/>
            <a:ext cx="6520220" cy="233883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7825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5650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8976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6758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387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7" y="2620980"/>
            <a:ext cx="3213847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7" y="3905482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8" y="1539427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8" y="1539427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825" indent="0">
              <a:buNone/>
              <a:defRPr sz="2315"/>
            </a:lvl2pPr>
            <a:lvl3pPr marL="755650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89760" indent="0">
              <a:buNone/>
              <a:defRPr sz="1655"/>
            </a:lvl6pPr>
            <a:lvl7pPr marL="2267585" indent="0">
              <a:buNone/>
              <a:defRPr sz="1655"/>
            </a:lvl7pPr>
            <a:lvl8pPr marL="2646045" indent="0">
              <a:buNone/>
              <a:defRPr sz="1655"/>
            </a:lvl8pPr>
            <a:lvl9pPr marL="3023870" indent="0">
              <a:buNone/>
              <a:defRPr sz="165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2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55650" rtl="0" eaLnBrk="1" latinLnBrk="0" hangingPunct="1">
        <a:lnSpc>
          <a:spcPct val="90000"/>
        </a:lnSpc>
        <a:spcBef>
          <a:spcPct val="0"/>
        </a:spcBef>
        <a:buNone/>
        <a:defRPr sz="36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230" indent="-189230" algn="l" defTabSz="75565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5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270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7011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207899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464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565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8976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758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387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6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11" Type="http://schemas.microsoft.com/office/2007/relationships/hdphoto" Target="../media/hdphoto2.wdp"/><Relationship Id="rId5" Type="http://schemas.openxmlformats.org/officeDocument/2006/relationships/chart" Target="../charts/chart3.xml"/><Relationship Id="rId10" Type="http://schemas.openxmlformats.org/officeDocument/2006/relationships/image" Target="../media/image2.png"/><Relationship Id="rId4" Type="http://schemas.openxmlformats.org/officeDocument/2006/relationships/chart" Target="../charts/chart2.xml"/><Relationship Id="rId9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组合 65">
            <a:extLst>
              <a:ext uri="{FF2B5EF4-FFF2-40B4-BE49-F238E27FC236}">
                <a16:creationId xmlns:a16="http://schemas.microsoft.com/office/drawing/2014/main" id="{B8A678B7-764B-FA85-41F7-6343179E90BB}"/>
              </a:ext>
            </a:extLst>
          </p:cNvPr>
          <p:cNvGrpSpPr/>
          <p:nvPr/>
        </p:nvGrpSpPr>
        <p:grpSpPr>
          <a:xfrm>
            <a:off x="1122929" y="537650"/>
            <a:ext cx="5446871" cy="3012961"/>
            <a:chOff x="1095220" y="472876"/>
            <a:chExt cx="5446871" cy="3012961"/>
          </a:xfrm>
        </p:grpSpPr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2A75F1D5-7025-0116-0DF7-87F0BB39AB88}"/>
                </a:ext>
              </a:extLst>
            </p:cNvPr>
            <p:cNvSpPr txBox="1"/>
            <p:nvPr/>
          </p:nvSpPr>
          <p:spPr>
            <a:xfrm>
              <a:off x="1095220" y="472876"/>
              <a:ext cx="153659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7014BC2E-F5F0-89E7-5197-01EE001CFD4E}"/>
                </a:ext>
              </a:extLst>
            </p:cNvPr>
            <p:cNvSpPr txBox="1"/>
            <p:nvPr/>
          </p:nvSpPr>
          <p:spPr>
            <a:xfrm>
              <a:off x="3369471" y="472876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78B4E896-E03C-1773-3D3E-A46FAEDB51E9}"/>
                </a:ext>
              </a:extLst>
            </p:cNvPr>
            <p:cNvSpPr txBox="1"/>
            <p:nvPr/>
          </p:nvSpPr>
          <p:spPr>
            <a:xfrm>
              <a:off x="4620812" y="472876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484943AB-995E-4375-C0E3-8B8B248E301C}"/>
                </a:ext>
              </a:extLst>
            </p:cNvPr>
            <p:cNvSpPr txBox="1"/>
            <p:nvPr/>
          </p:nvSpPr>
          <p:spPr>
            <a:xfrm>
              <a:off x="1095220" y="2135484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BF030BAE-3ED9-01A7-F1DB-79596FA7ADCA}"/>
                </a:ext>
              </a:extLst>
            </p:cNvPr>
            <p:cNvSpPr txBox="1"/>
            <p:nvPr/>
          </p:nvSpPr>
          <p:spPr>
            <a:xfrm>
              <a:off x="2400989" y="2135484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2" name="组合 71">
              <a:extLst>
                <a:ext uri="{FF2B5EF4-FFF2-40B4-BE49-F238E27FC236}">
                  <a16:creationId xmlns:a16="http://schemas.microsoft.com/office/drawing/2014/main" id="{FEA7CA36-3729-410C-492C-1BB19E9FA3B4}"/>
                </a:ext>
              </a:extLst>
            </p:cNvPr>
            <p:cNvGrpSpPr/>
            <p:nvPr/>
          </p:nvGrpSpPr>
          <p:grpSpPr>
            <a:xfrm>
              <a:off x="1315735" y="2227209"/>
              <a:ext cx="1230981" cy="1239157"/>
              <a:chOff x="6087013" y="595397"/>
              <a:chExt cx="1230981" cy="1239157"/>
            </a:xfrm>
          </p:grpSpPr>
          <p:graphicFrame>
            <p:nvGraphicFramePr>
              <p:cNvPr id="133" name="图表 132">
                <a:extLst>
                  <a:ext uri="{FF2B5EF4-FFF2-40B4-BE49-F238E27FC236}">
                    <a16:creationId xmlns:a16="http://schemas.microsoft.com/office/drawing/2014/main" id="{73CB8D7D-2B4C-2336-53D8-E3876D2FE46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92583636"/>
                  </p:ext>
                </p:extLst>
              </p:nvPr>
            </p:nvGraphicFramePr>
            <p:xfrm>
              <a:off x="6165994" y="595397"/>
              <a:ext cx="1152000" cy="108870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B74156E0-7461-75A7-B17A-33E2B751F7E4}"/>
                  </a:ext>
                </a:extLst>
              </p:cNvPr>
              <p:cNvSpPr txBox="1"/>
              <p:nvPr/>
            </p:nvSpPr>
            <p:spPr>
              <a:xfrm rot="19648842">
                <a:off x="6415860" y="1656090"/>
                <a:ext cx="329924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defRPr/>
                </a:pP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7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43A47C3D-AFA5-1649-D633-677D4F5DF28D}"/>
                  </a:ext>
                </a:extLst>
              </p:cNvPr>
              <p:cNvSpPr txBox="1"/>
              <p:nvPr/>
            </p:nvSpPr>
            <p:spPr>
              <a:xfrm rot="19648842">
                <a:off x="6464188" y="1726832"/>
                <a:ext cx="633613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defRPr/>
                </a:pP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A NONOate</a:t>
                </a:r>
                <a:endParaRPr lang="zh-CN" altLang="en-US" sz="7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文本框 215">
                <a:extLst>
                  <a:ext uri="{FF2B5EF4-FFF2-40B4-BE49-F238E27FC236}">
                    <a16:creationId xmlns:a16="http://schemas.microsoft.com/office/drawing/2014/main" id="{1AEF2AA5-F4E4-BD2D-3653-F657770EF4C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5400000" flipV="1">
                <a:off x="5838309" y="1059042"/>
                <a:ext cx="60512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9pPr>
              </a:lstStyle>
              <a:p>
                <a:pPr algn="ctr">
                  <a:defRPr/>
                </a:pP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 of MLg2908</a:t>
                </a:r>
                <a:endParaRPr lang="zh-CN" altLang="en-US" sz="7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7A1E95E4-546F-6D71-CA54-7A769B6853E5}"/>
                </a:ext>
              </a:extLst>
            </p:cNvPr>
            <p:cNvSpPr txBox="1"/>
            <p:nvPr/>
          </p:nvSpPr>
          <p:spPr>
            <a:xfrm>
              <a:off x="3734772" y="2135484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4" name="组合 73">
              <a:extLst>
                <a:ext uri="{FF2B5EF4-FFF2-40B4-BE49-F238E27FC236}">
                  <a16:creationId xmlns:a16="http://schemas.microsoft.com/office/drawing/2014/main" id="{00515CEC-3CEA-39C4-8BCA-ECF59B09AB8B}"/>
                </a:ext>
              </a:extLst>
            </p:cNvPr>
            <p:cNvGrpSpPr/>
            <p:nvPr/>
          </p:nvGrpSpPr>
          <p:grpSpPr>
            <a:xfrm>
              <a:off x="2615672" y="2284921"/>
              <a:ext cx="1343591" cy="1200916"/>
              <a:chOff x="4654355" y="2419677"/>
              <a:chExt cx="1343591" cy="1200916"/>
            </a:xfrm>
          </p:grpSpPr>
          <p:grpSp>
            <p:nvGrpSpPr>
              <p:cNvPr id="126" name="组合 125">
                <a:extLst>
                  <a:ext uri="{FF2B5EF4-FFF2-40B4-BE49-F238E27FC236}">
                    <a16:creationId xmlns:a16="http://schemas.microsoft.com/office/drawing/2014/main" id="{EE29DC0E-F2F2-F85A-6E64-B4E94D59FAD4}"/>
                  </a:ext>
                </a:extLst>
              </p:cNvPr>
              <p:cNvGrpSpPr/>
              <p:nvPr/>
            </p:nvGrpSpPr>
            <p:grpSpPr>
              <a:xfrm>
                <a:off x="4654355" y="2480838"/>
                <a:ext cx="1343591" cy="1139755"/>
                <a:chOff x="4867715" y="2480838"/>
                <a:chExt cx="1343591" cy="1139755"/>
              </a:xfrm>
            </p:grpSpPr>
            <p:graphicFrame>
              <p:nvGraphicFramePr>
                <p:cNvPr id="128" name="图表 127">
                  <a:extLst>
                    <a:ext uri="{FF2B5EF4-FFF2-40B4-BE49-F238E27FC236}">
                      <a16:creationId xmlns:a16="http://schemas.microsoft.com/office/drawing/2014/main" id="{85D801B7-D2A8-ED33-375B-DC7DAEB1DAE2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78257760"/>
                    </p:ext>
                  </p:extLst>
                </p:nvPr>
              </p:nvGraphicFramePr>
              <p:xfrm>
                <a:off x="5023306" y="2480838"/>
                <a:ext cx="1188000" cy="108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29" name="文本框 215">
                  <a:extLst>
                    <a:ext uri="{FF2B5EF4-FFF2-40B4-BE49-F238E27FC236}">
                      <a16:creationId xmlns:a16="http://schemas.microsoft.com/office/drawing/2014/main" id="{59725ADC-BF52-8E76-1CA0-6DF831AC992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5400000" flipV="1">
                  <a:off x="4619011" y="2854204"/>
                  <a:ext cx="605129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9pPr>
                </a:lstStyle>
                <a:p>
                  <a:pPr algn="ctr">
                    <a:defRPr/>
                  </a:pPr>
                  <a:r>
                    <a:rPr lang="en-US" altLang="zh-CN" sz="700" i="1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gf7</a:t>
                  </a: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NA</a:t>
                  </a:r>
                  <a:endParaRPr lang="zh-CN" altLang="en-US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文本框 129">
                  <a:extLst>
                    <a:ext uri="{FF2B5EF4-FFF2-40B4-BE49-F238E27FC236}">
                      <a16:creationId xmlns:a16="http://schemas.microsoft.com/office/drawing/2014/main" id="{8694BFD9-394B-F9D5-1414-C5AD85B9AA46}"/>
                    </a:ext>
                  </a:extLst>
                </p:cNvPr>
                <p:cNvSpPr txBox="1"/>
                <p:nvPr/>
              </p:nvSpPr>
              <p:spPr>
                <a:xfrm rot="19648842">
                  <a:off x="5213798" y="3435701"/>
                  <a:ext cx="329924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>
                    <a:defRPr/>
                  </a:pP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zh-CN" altLang="en-US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文本框 130">
                  <a:extLst>
                    <a:ext uri="{FF2B5EF4-FFF2-40B4-BE49-F238E27FC236}">
                      <a16:creationId xmlns:a16="http://schemas.microsoft.com/office/drawing/2014/main" id="{0F5CC89D-C74C-FCC2-0F0F-74652EFDDBB7}"/>
                    </a:ext>
                  </a:extLst>
                </p:cNvPr>
                <p:cNvSpPr txBox="1"/>
                <p:nvPr/>
              </p:nvSpPr>
              <p:spPr>
                <a:xfrm rot="19648842">
                  <a:off x="5266039" y="3512871"/>
                  <a:ext cx="655366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>
                    <a:defRPr/>
                  </a:pP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EA NONOate</a:t>
                  </a:r>
                  <a:endParaRPr lang="zh-CN" altLang="en-US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7" name="文本框 74">
                <a:extLst>
                  <a:ext uri="{FF2B5EF4-FFF2-40B4-BE49-F238E27FC236}">
                    <a16:creationId xmlns:a16="http://schemas.microsoft.com/office/drawing/2014/main" id="{67088DA9-16CE-F38C-81BC-D2E60E827ED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230877" y="2419677"/>
                <a:ext cx="5400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CC0000"/>
                  </a:buClr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CC0000"/>
                  </a:buClr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CC0000"/>
                  </a:buClr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CC0000"/>
                  </a:buClr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ClrTx/>
                  <a:buFontTx/>
                  <a:buNone/>
                </a:pPr>
                <a:r>
                  <a:rPr lang="en-US" altLang="zh-CN" sz="700" dirty="0">
                    <a:solidFill>
                      <a:prstClr val="black"/>
                    </a:solidFill>
                    <a:ea typeface="黑体" panose="02010609060101010101" pitchFamily="49" charset="-122"/>
                  </a:rPr>
                  <a:t>MLg2908</a:t>
                </a:r>
                <a:endParaRPr lang="zh-CN" altLang="en-US" sz="700" dirty="0">
                  <a:solidFill>
                    <a:prstClr val="black"/>
                  </a:solidFill>
                  <a:ea typeface="黑体" panose="02010609060101010101" pitchFamily="49" charset="-122"/>
                </a:endParaRPr>
              </a:p>
            </p:txBody>
          </p:sp>
        </p:grpSp>
        <p:grpSp>
          <p:nvGrpSpPr>
            <p:cNvPr id="75" name="组合 74">
              <a:extLst>
                <a:ext uri="{FF2B5EF4-FFF2-40B4-BE49-F238E27FC236}">
                  <a16:creationId xmlns:a16="http://schemas.microsoft.com/office/drawing/2014/main" id="{EEE495AB-B9A1-28C4-054B-A4D5736E13A5}"/>
                </a:ext>
              </a:extLst>
            </p:cNvPr>
            <p:cNvGrpSpPr/>
            <p:nvPr/>
          </p:nvGrpSpPr>
          <p:grpSpPr>
            <a:xfrm>
              <a:off x="3956776" y="2273531"/>
              <a:ext cx="1323835" cy="1197171"/>
              <a:chOff x="5987904" y="2419677"/>
              <a:chExt cx="1323835" cy="1197171"/>
            </a:xfrm>
          </p:grpSpPr>
          <p:grpSp>
            <p:nvGrpSpPr>
              <p:cNvPr id="113" name="组合 112">
                <a:extLst>
                  <a:ext uri="{FF2B5EF4-FFF2-40B4-BE49-F238E27FC236}">
                    <a16:creationId xmlns:a16="http://schemas.microsoft.com/office/drawing/2014/main" id="{D7152484-8299-AA28-28B2-1255CCEE228A}"/>
                  </a:ext>
                </a:extLst>
              </p:cNvPr>
              <p:cNvGrpSpPr/>
              <p:nvPr/>
            </p:nvGrpSpPr>
            <p:grpSpPr>
              <a:xfrm>
                <a:off x="5987904" y="2464848"/>
                <a:ext cx="1323835" cy="1152000"/>
                <a:chOff x="6213456" y="2464848"/>
                <a:chExt cx="1323835" cy="1152000"/>
              </a:xfrm>
            </p:grpSpPr>
            <p:graphicFrame>
              <p:nvGraphicFramePr>
                <p:cNvPr id="117" name="图表 116">
                  <a:extLst>
                    <a:ext uri="{FF2B5EF4-FFF2-40B4-BE49-F238E27FC236}">
                      <a16:creationId xmlns:a16="http://schemas.microsoft.com/office/drawing/2014/main" id="{08E53953-E47D-F7A9-7D56-56C7A0D94AC2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490176790"/>
                    </p:ext>
                  </p:extLst>
                </p:nvPr>
              </p:nvGraphicFramePr>
              <p:xfrm>
                <a:off x="6385291" y="2464848"/>
                <a:ext cx="1152000" cy="1152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119" name="文本框 118">
                  <a:extLst>
                    <a:ext uri="{FF2B5EF4-FFF2-40B4-BE49-F238E27FC236}">
                      <a16:creationId xmlns:a16="http://schemas.microsoft.com/office/drawing/2014/main" id="{3A1DAA1F-F433-EE63-9F3F-1AE169F4CEBE}"/>
                    </a:ext>
                  </a:extLst>
                </p:cNvPr>
                <p:cNvSpPr txBox="1"/>
                <p:nvPr/>
              </p:nvSpPr>
              <p:spPr>
                <a:xfrm rot="19648842">
                  <a:off x="6571095" y="3440446"/>
                  <a:ext cx="329924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>
                    <a:defRPr/>
                  </a:pP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zh-CN" altLang="en-US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文本框 123">
                  <a:extLst>
                    <a:ext uri="{FF2B5EF4-FFF2-40B4-BE49-F238E27FC236}">
                      <a16:creationId xmlns:a16="http://schemas.microsoft.com/office/drawing/2014/main" id="{4D3895B0-D872-18CF-671C-838743C85D8B}"/>
                    </a:ext>
                  </a:extLst>
                </p:cNvPr>
                <p:cNvSpPr txBox="1"/>
                <p:nvPr/>
              </p:nvSpPr>
              <p:spPr>
                <a:xfrm rot="19648842">
                  <a:off x="6664504" y="3495493"/>
                  <a:ext cx="604795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>
                    <a:defRPr/>
                  </a:pP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EA NONOate</a:t>
                  </a:r>
                  <a:endParaRPr lang="zh-CN" altLang="en-US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文本框 215">
                  <a:extLst>
                    <a:ext uri="{FF2B5EF4-FFF2-40B4-BE49-F238E27FC236}">
                      <a16:creationId xmlns:a16="http://schemas.microsoft.com/office/drawing/2014/main" id="{152DEF47-4A52-DCDD-713C-219BA7269FA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5400000" flipV="1">
                  <a:off x="5964752" y="2854204"/>
                  <a:ext cx="605129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9pPr>
                </a:lstStyle>
                <a:p>
                  <a:pPr algn="ctr">
                    <a:defRPr/>
                  </a:pPr>
                  <a:r>
                    <a:rPr lang="en-US" altLang="zh-CN" sz="700" i="1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gf10</a:t>
                  </a: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NA</a:t>
                  </a:r>
                  <a:endParaRPr lang="zh-CN" altLang="en-US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5" name="文本框 74">
                <a:extLst>
                  <a:ext uri="{FF2B5EF4-FFF2-40B4-BE49-F238E27FC236}">
                    <a16:creationId xmlns:a16="http://schemas.microsoft.com/office/drawing/2014/main" id="{D3168A6F-B099-9B8E-3988-B2734FDA9EC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575297" y="2419677"/>
                <a:ext cx="5400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CC0000"/>
                  </a:buClr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CC0000"/>
                  </a:buClr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CC0000"/>
                  </a:buClr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CC0000"/>
                  </a:buClr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ClrTx/>
                  <a:buFontTx/>
                  <a:buNone/>
                </a:pPr>
                <a:r>
                  <a:rPr lang="en-US" altLang="zh-CN" sz="700" dirty="0">
                    <a:solidFill>
                      <a:prstClr val="black"/>
                    </a:solidFill>
                    <a:ea typeface="黑体" panose="02010609060101010101" pitchFamily="49" charset="-122"/>
                  </a:rPr>
                  <a:t>MLg2908</a:t>
                </a:r>
                <a:endParaRPr lang="zh-CN" altLang="en-US" sz="700" dirty="0">
                  <a:solidFill>
                    <a:prstClr val="black"/>
                  </a:solidFill>
                  <a:ea typeface="黑体" panose="02010609060101010101" pitchFamily="49" charset="-122"/>
                </a:endParaRPr>
              </a:p>
            </p:txBody>
          </p:sp>
        </p:grpSp>
        <p:grpSp>
          <p:nvGrpSpPr>
            <p:cNvPr id="76" name="组合 75">
              <a:extLst>
                <a:ext uri="{FF2B5EF4-FFF2-40B4-BE49-F238E27FC236}">
                  <a16:creationId xmlns:a16="http://schemas.microsoft.com/office/drawing/2014/main" id="{C69A9D7B-2663-2D9C-280F-0433F9F14489}"/>
                </a:ext>
              </a:extLst>
            </p:cNvPr>
            <p:cNvGrpSpPr/>
            <p:nvPr/>
          </p:nvGrpSpPr>
          <p:grpSpPr>
            <a:xfrm>
              <a:off x="5278130" y="2239526"/>
              <a:ext cx="1263961" cy="1236103"/>
              <a:chOff x="239351" y="4141115"/>
              <a:chExt cx="1263961" cy="1236103"/>
            </a:xfrm>
          </p:grpSpPr>
          <p:grpSp>
            <p:nvGrpSpPr>
              <p:cNvPr id="107" name="组合 106">
                <a:extLst>
                  <a:ext uri="{FF2B5EF4-FFF2-40B4-BE49-F238E27FC236}">
                    <a16:creationId xmlns:a16="http://schemas.microsoft.com/office/drawing/2014/main" id="{883251EF-9665-DC00-D0E0-152A45C077E1}"/>
                  </a:ext>
                </a:extLst>
              </p:cNvPr>
              <p:cNvGrpSpPr/>
              <p:nvPr/>
            </p:nvGrpSpPr>
            <p:grpSpPr>
              <a:xfrm>
                <a:off x="239351" y="4141115"/>
                <a:ext cx="1263961" cy="1236103"/>
                <a:chOff x="4893257" y="4272621"/>
                <a:chExt cx="1263961" cy="1236103"/>
              </a:xfrm>
            </p:grpSpPr>
            <p:graphicFrame>
              <p:nvGraphicFramePr>
                <p:cNvPr id="109" name="图表 108">
                  <a:extLst>
                    <a:ext uri="{FF2B5EF4-FFF2-40B4-BE49-F238E27FC236}">
                      <a16:creationId xmlns:a16="http://schemas.microsoft.com/office/drawing/2014/main" id="{CF066EDC-BF18-EE8B-53E4-288AC2DE2621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342935098"/>
                    </p:ext>
                  </p:extLst>
                </p:nvPr>
              </p:nvGraphicFramePr>
              <p:xfrm>
                <a:off x="4969218" y="4272621"/>
                <a:ext cx="1188000" cy="108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110" name="文本框 215">
                  <a:extLst>
                    <a:ext uri="{FF2B5EF4-FFF2-40B4-BE49-F238E27FC236}">
                      <a16:creationId xmlns:a16="http://schemas.microsoft.com/office/drawing/2014/main" id="{B4F38B5A-E596-18AD-1353-161A43AA2A4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5400000" flipV="1">
                  <a:off x="4644553" y="4745278"/>
                  <a:ext cx="605129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ea typeface="宋体" charset="-122"/>
                    </a:defRPr>
                  </a:lvl9pPr>
                </a:lstStyle>
                <a:p>
                  <a:pPr algn="ctr">
                    <a:defRPr/>
                  </a:pPr>
                  <a:r>
                    <a:rPr lang="en-US" altLang="zh-CN" sz="700" i="1" kern="0" dirty="0" err="1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gf</a:t>
                  </a: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NA</a:t>
                  </a:r>
                  <a:endParaRPr lang="zh-CN" altLang="en-US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文本框 110">
                  <a:extLst>
                    <a:ext uri="{FF2B5EF4-FFF2-40B4-BE49-F238E27FC236}">
                      <a16:creationId xmlns:a16="http://schemas.microsoft.com/office/drawing/2014/main" id="{CF82191C-348B-9222-DA4D-0AAD784FCB4C}"/>
                    </a:ext>
                  </a:extLst>
                </p:cNvPr>
                <p:cNvSpPr txBox="1"/>
                <p:nvPr/>
              </p:nvSpPr>
              <p:spPr>
                <a:xfrm rot="19648842">
                  <a:off x="5242321" y="5320077"/>
                  <a:ext cx="329924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>
                    <a:defRPr/>
                  </a:pP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zh-CN" altLang="en-US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文本框 111">
                  <a:extLst>
                    <a:ext uri="{FF2B5EF4-FFF2-40B4-BE49-F238E27FC236}">
                      <a16:creationId xmlns:a16="http://schemas.microsoft.com/office/drawing/2014/main" id="{ACA4CE17-5026-84C2-F796-6689290AA9B0}"/>
                    </a:ext>
                  </a:extLst>
                </p:cNvPr>
                <p:cNvSpPr txBox="1"/>
                <p:nvPr/>
              </p:nvSpPr>
              <p:spPr>
                <a:xfrm rot="19648842">
                  <a:off x="5278918" y="5401002"/>
                  <a:ext cx="661070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>
                    <a:defRPr/>
                  </a:pP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EA NONOate</a:t>
                  </a:r>
                  <a:endParaRPr lang="zh-CN" altLang="en-US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8" name="文本框 74">
                <a:extLst>
                  <a:ext uri="{FF2B5EF4-FFF2-40B4-BE49-F238E27FC236}">
                    <a16:creationId xmlns:a16="http://schemas.microsoft.com/office/drawing/2014/main" id="{F9ABF282-FA52-4251-960C-E1D7D18784C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80575" y="4178227"/>
                <a:ext cx="5400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CC0000"/>
                  </a:buClr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CC0000"/>
                  </a:buClr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CC0000"/>
                  </a:buClr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CC0000"/>
                  </a:buClr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ClrTx/>
                  <a:buFontTx/>
                  <a:buNone/>
                </a:pPr>
                <a:r>
                  <a:rPr lang="en-US" altLang="zh-CN" sz="700" dirty="0">
                    <a:solidFill>
                      <a:prstClr val="black"/>
                    </a:solidFill>
                    <a:ea typeface="黑体" panose="02010609060101010101" pitchFamily="49" charset="-122"/>
                  </a:rPr>
                  <a:t>MLg2908</a:t>
                </a:r>
                <a:endParaRPr lang="zh-CN" altLang="en-US" sz="700" dirty="0">
                  <a:solidFill>
                    <a:prstClr val="black"/>
                  </a:solidFill>
                  <a:ea typeface="黑体" panose="02010609060101010101" pitchFamily="49" charset="-122"/>
                </a:endParaRPr>
              </a:p>
            </p:txBody>
          </p:sp>
        </p:grpSp>
        <p:grpSp>
          <p:nvGrpSpPr>
            <p:cNvPr id="77" name="组合 76">
              <a:extLst>
                <a:ext uri="{FF2B5EF4-FFF2-40B4-BE49-F238E27FC236}">
                  <a16:creationId xmlns:a16="http://schemas.microsoft.com/office/drawing/2014/main" id="{0F8B346D-A183-7701-DE20-036BBA2E6D6D}"/>
                </a:ext>
              </a:extLst>
            </p:cNvPr>
            <p:cNvGrpSpPr/>
            <p:nvPr/>
          </p:nvGrpSpPr>
          <p:grpSpPr>
            <a:xfrm>
              <a:off x="3630140" y="592206"/>
              <a:ext cx="1159545" cy="1258020"/>
              <a:chOff x="-230860" y="3587212"/>
              <a:chExt cx="1418860" cy="1473881"/>
            </a:xfrm>
          </p:grpSpPr>
          <p:sp>
            <p:nvSpPr>
              <p:cNvPr id="102" name="文本框 74">
                <a:extLst>
                  <a:ext uri="{FF2B5EF4-FFF2-40B4-BE49-F238E27FC236}">
                    <a16:creationId xmlns:a16="http://schemas.microsoft.com/office/drawing/2014/main" id="{2AEA5A6D-26F1-CBF0-9B30-89583335CAD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-679779" y="4123926"/>
                <a:ext cx="1029650" cy="131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9pPr>
              </a:lstStyle>
              <a:p>
                <a:pPr algn="ctr">
                  <a:defRPr/>
                </a:pP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rganoid size (</a:t>
                </a:r>
                <a:r>
                  <a:rPr lang="en-US" altLang="zh-CN" sz="7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m</a:t>
                </a: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7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103" name="图表 102">
                <a:extLst>
                  <a:ext uri="{FF2B5EF4-FFF2-40B4-BE49-F238E27FC236}">
                    <a16:creationId xmlns:a16="http://schemas.microsoft.com/office/drawing/2014/main" id="{BB87C76B-1479-3D6B-9A48-1038BB6F4B1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8085354"/>
                  </p:ext>
                </p:extLst>
              </p:nvPr>
            </p:nvGraphicFramePr>
            <p:xfrm>
              <a:off x="-144000" y="3587212"/>
              <a:ext cx="1332000" cy="1296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838C0224-6EF2-B7DD-7DAF-BDA3CFDE64F5}"/>
                  </a:ext>
                </a:extLst>
              </p:cNvPr>
              <p:cNvSpPr txBox="1"/>
              <p:nvPr/>
            </p:nvSpPr>
            <p:spPr>
              <a:xfrm rot="19648842">
                <a:off x="88598" y="4833909"/>
                <a:ext cx="411521" cy="12620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defRPr/>
                </a:pP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7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AA3B1344-F728-2C0B-17E5-742F7901051D}"/>
                  </a:ext>
                </a:extLst>
              </p:cNvPr>
              <p:cNvSpPr txBox="1"/>
              <p:nvPr/>
            </p:nvSpPr>
            <p:spPr>
              <a:xfrm rot="19648842">
                <a:off x="94948" y="4934887"/>
                <a:ext cx="832005" cy="12620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defRPr/>
                </a:pP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A NONOate</a:t>
                </a:r>
                <a:endParaRPr lang="zh-CN" altLang="en-US" sz="7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Box 129">
                <a:extLst>
                  <a:ext uri="{FF2B5EF4-FFF2-40B4-BE49-F238E27FC236}">
                    <a16:creationId xmlns:a16="http://schemas.microsoft.com/office/drawing/2014/main" id="{06224454-0CC6-7E7A-2EB3-43CC52DBF218}"/>
                  </a:ext>
                </a:extLst>
              </p:cNvPr>
              <p:cNvSpPr txBox="1"/>
              <p:nvPr/>
            </p:nvSpPr>
            <p:spPr>
              <a:xfrm>
                <a:off x="576800" y="4059197"/>
                <a:ext cx="479417" cy="25241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>
                  <a:defRPr/>
                </a:pPr>
                <a:r>
                  <a:rPr lang="en-US" altLang="zh-CN" sz="1400" kern="0" dirty="0">
                    <a:solidFill>
                      <a:prstClr val="black"/>
                    </a:solidFill>
                    <a:cs typeface="Arial" panose="020B0604020202020204" pitchFamily="34" charset="0"/>
                  </a:rPr>
                  <a:t>****</a:t>
                </a:r>
                <a:endParaRPr lang="zh-CN" altLang="en-US" sz="1400" kern="0" dirty="0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51E38F08-8C34-8602-40A2-DE30C72DE3EA}"/>
                </a:ext>
              </a:extLst>
            </p:cNvPr>
            <p:cNvGrpSpPr/>
            <p:nvPr/>
          </p:nvGrpSpPr>
          <p:grpSpPr>
            <a:xfrm>
              <a:off x="1316386" y="622733"/>
              <a:ext cx="2073951" cy="1143026"/>
              <a:chOff x="473028" y="415213"/>
              <a:chExt cx="2073951" cy="1143026"/>
            </a:xfrm>
          </p:grpSpPr>
          <p:sp>
            <p:nvSpPr>
              <p:cNvPr id="96" name="文本框 74">
                <a:extLst>
                  <a:ext uri="{FF2B5EF4-FFF2-40B4-BE49-F238E27FC236}">
                    <a16:creationId xmlns:a16="http://schemas.microsoft.com/office/drawing/2014/main" id="{D0E1ECA8-EB73-4DA8-280F-774619E6C28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15242" y="415213"/>
                <a:ext cx="5040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CC0000"/>
                  </a:buClr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CC0000"/>
                  </a:buClr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CC0000"/>
                  </a:buClr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CC0000"/>
                  </a:buClr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ClrTx/>
                  <a:buFontTx/>
                  <a:buNone/>
                </a:pPr>
                <a:r>
                  <a:rPr lang="en-US" altLang="zh-CN" sz="700" dirty="0">
                    <a:solidFill>
                      <a:prstClr val="black"/>
                    </a:solidFill>
                    <a:ea typeface="黑体" panose="02010609060101010101" pitchFamily="49" charset="-122"/>
                  </a:rPr>
                  <a:t>Control</a:t>
                </a:r>
                <a:endParaRPr lang="zh-CN" altLang="en-US" sz="700" dirty="0">
                  <a:solidFill>
                    <a:prstClr val="black"/>
                  </a:solidFill>
                  <a:ea typeface="黑体" panose="02010609060101010101" pitchFamily="49" charset="-122"/>
                </a:endParaRPr>
              </a:p>
            </p:txBody>
          </p:sp>
          <p:sp>
            <p:nvSpPr>
              <p:cNvPr id="97" name="文本框 92">
                <a:extLst>
                  <a:ext uri="{FF2B5EF4-FFF2-40B4-BE49-F238E27FC236}">
                    <a16:creationId xmlns:a16="http://schemas.microsoft.com/office/drawing/2014/main" id="{2484520B-0CFA-1827-2EF4-95487266659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466979" y="415213"/>
                <a:ext cx="108000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CC0000"/>
                  </a:buClr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CC0000"/>
                  </a:buClr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CC0000"/>
                  </a:buClr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CC0000"/>
                  </a:buClr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CC0000"/>
                  </a:buClr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spcBef>
                    <a:spcPct val="0"/>
                  </a:spcBef>
                  <a:buClrTx/>
                  <a:buFontTx/>
                  <a:buNone/>
                </a:pPr>
                <a:r>
                  <a:rPr lang="en-US" altLang="zh-CN" sz="700" dirty="0">
                    <a:solidFill>
                      <a:prstClr val="black"/>
                    </a:solidFill>
                    <a:ea typeface="黑体" panose="02010609060101010101" pitchFamily="49" charset="-122"/>
                  </a:rPr>
                  <a:t>DEA NONOate</a:t>
                </a:r>
                <a:endParaRPr lang="zh-CN" altLang="en-US" sz="400" dirty="0">
                  <a:solidFill>
                    <a:prstClr val="black"/>
                  </a:solidFill>
                  <a:ea typeface="黑体" panose="02010609060101010101" pitchFamily="49" charset="-122"/>
                </a:endParaRPr>
              </a:p>
            </p:txBody>
          </p:sp>
          <p:pic>
            <p:nvPicPr>
              <p:cNvPr id="98" name="图片 97">
                <a:extLst>
                  <a:ext uri="{FF2B5EF4-FFF2-40B4-BE49-F238E27FC236}">
                    <a16:creationId xmlns:a16="http://schemas.microsoft.com/office/drawing/2014/main" id="{AC43C41C-85BE-9A74-158D-FE91CE958F5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250" t="10170" r="10250" b="11964"/>
              <a:stretch>
                <a:fillRect/>
              </a:stretch>
            </p:blipFill>
            <p:spPr>
              <a:xfrm>
                <a:off x="473028" y="550239"/>
                <a:ext cx="1007468" cy="1008000"/>
              </a:xfrm>
              <a:custGeom>
                <a:avLst/>
                <a:gdLst>
                  <a:gd name="connsiteX0" fmla="*/ 572400 w 1144800"/>
                  <a:gd name="connsiteY0" fmla="*/ 0 h 1145404"/>
                  <a:gd name="connsiteX1" fmla="*/ 1144800 w 1144800"/>
                  <a:gd name="connsiteY1" fmla="*/ 572702 h 1145404"/>
                  <a:gd name="connsiteX2" fmla="*/ 572400 w 1144800"/>
                  <a:gd name="connsiteY2" fmla="*/ 1145404 h 1145404"/>
                  <a:gd name="connsiteX3" fmla="*/ 0 w 1144800"/>
                  <a:gd name="connsiteY3" fmla="*/ 572702 h 1145404"/>
                  <a:gd name="connsiteX4" fmla="*/ 572400 w 1144800"/>
                  <a:gd name="connsiteY4" fmla="*/ 0 h 11454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144800" h="1145404">
                    <a:moveTo>
                      <a:pt x="572400" y="0"/>
                    </a:moveTo>
                    <a:cubicBezTo>
                      <a:pt x="888528" y="0"/>
                      <a:pt x="1144800" y="256407"/>
                      <a:pt x="1144800" y="572702"/>
                    </a:cubicBezTo>
                    <a:cubicBezTo>
                      <a:pt x="1144800" y="888997"/>
                      <a:pt x="888528" y="1145404"/>
                      <a:pt x="572400" y="1145404"/>
                    </a:cubicBezTo>
                    <a:cubicBezTo>
                      <a:pt x="256272" y="1145404"/>
                      <a:pt x="0" y="888997"/>
                      <a:pt x="0" y="572702"/>
                    </a:cubicBezTo>
                    <a:cubicBezTo>
                      <a:pt x="0" y="256407"/>
                      <a:pt x="256272" y="0"/>
                      <a:pt x="572400" y="0"/>
                    </a:cubicBezTo>
                    <a:close/>
                  </a:path>
                </a:pathLst>
              </a:custGeom>
            </p:spPr>
          </p:pic>
          <p:pic>
            <p:nvPicPr>
              <p:cNvPr id="99" name="图片 98">
                <a:extLst>
                  <a:ext uri="{FF2B5EF4-FFF2-40B4-BE49-F238E27FC236}">
                    <a16:creationId xmlns:a16="http://schemas.microsoft.com/office/drawing/2014/main" id="{C01CD463-91C4-51A6-96CC-C6859059AF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095" t="12275" r="7405" b="11015"/>
              <a:stretch>
                <a:fillRect/>
              </a:stretch>
            </p:blipFill>
            <p:spPr>
              <a:xfrm>
                <a:off x="1518227" y="550239"/>
                <a:ext cx="1007468" cy="1008000"/>
              </a:xfrm>
              <a:custGeom>
                <a:avLst/>
                <a:gdLst>
                  <a:gd name="connsiteX0" fmla="*/ 572400 w 1144800"/>
                  <a:gd name="connsiteY0" fmla="*/ 0 h 1145404"/>
                  <a:gd name="connsiteX1" fmla="*/ 1144800 w 1144800"/>
                  <a:gd name="connsiteY1" fmla="*/ 572702 h 1145404"/>
                  <a:gd name="connsiteX2" fmla="*/ 572400 w 1144800"/>
                  <a:gd name="connsiteY2" fmla="*/ 1145404 h 1145404"/>
                  <a:gd name="connsiteX3" fmla="*/ 0 w 1144800"/>
                  <a:gd name="connsiteY3" fmla="*/ 572702 h 1145404"/>
                  <a:gd name="connsiteX4" fmla="*/ 572400 w 1144800"/>
                  <a:gd name="connsiteY4" fmla="*/ 0 h 11454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144800" h="1145404">
                    <a:moveTo>
                      <a:pt x="572400" y="0"/>
                    </a:moveTo>
                    <a:cubicBezTo>
                      <a:pt x="888528" y="0"/>
                      <a:pt x="1144800" y="256407"/>
                      <a:pt x="1144800" y="572702"/>
                    </a:cubicBezTo>
                    <a:cubicBezTo>
                      <a:pt x="1144800" y="888997"/>
                      <a:pt x="888528" y="1145404"/>
                      <a:pt x="572400" y="1145404"/>
                    </a:cubicBezTo>
                    <a:cubicBezTo>
                      <a:pt x="256272" y="1145404"/>
                      <a:pt x="0" y="888997"/>
                      <a:pt x="0" y="572702"/>
                    </a:cubicBezTo>
                    <a:cubicBezTo>
                      <a:pt x="0" y="256407"/>
                      <a:pt x="256272" y="0"/>
                      <a:pt x="572400" y="0"/>
                    </a:cubicBezTo>
                    <a:close/>
                  </a:path>
                </a:pathLst>
              </a:custGeom>
            </p:spPr>
          </p:pic>
          <p:cxnSp>
            <p:nvCxnSpPr>
              <p:cNvPr id="100" name="直接连接符 99">
                <a:extLst>
                  <a:ext uri="{FF2B5EF4-FFF2-40B4-BE49-F238E27FC236}">
                    <a16:creationId xmlns:a16="http://schemas.microsoft.com/office/drawing/2014/main" id="{848E993F-CF09-EB0D-7214-01F3F0CC7206}"/>
                  </a:ext>
                </a:extLst>
              </p:cNvPr>
              <p:cNvCxnSpPr/>
              <p:nvPr/>
            </p:nvCxnSpPr>
            <p:spPr>
              <a:xfrm>
                <a:off x="913143" y="1490878"/>
                <a:ext cx="130582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直接连接符 100">
                <a:extLst>
                  <a:ext uri="{FF2B5EF4-FFF2-40B4-BE49-F238E27FC236}">
                    <a16:creationId xmlns:a16="http://schemas.microsoft.com/office/drawing/2014/main" id="{25F8D81E-FC38-8CBF-970A-DC8A1E82B266}"/>
                  </a:ext>
                </a:extLst>
              </p:cNvPr>
              <p:cNvCxnSpPr/>
              <p:nvPr/>
            </p:nvCxnSpPr>
            <p:spPr>
              <a:xfrm>
                <a:off x="1964072" y="1496270"/>
                <a:ext cx="130582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组合 78">
              <a:extLst>
                <a:ext uri="{FF2B5EF4-FFF2-40B4-BE49-F238E27FC236}">
                  <a16:creationId xmlns:a16="http://schemas.microsoft.com/office/drawing/2014/main" id="{F79605AF-6543-B494-0B40-91B09C597808}"/>
                </a:ext>
              </a:extLst>
            </p:cNvPr>
            <p:cNvGrpSpPr/>
            <p:nvPr/>
          </p:nvGrpSpPr>
          <p:grpSpPr>
            <a:xfrm>
              <a:off x="4882772" y="607198"/>
              <a:ext cx="1070900" cy="1290070"/>
              <a:chOff x="11786673" y="900433"/>
              <a:chExt cx="1070900" cy="1290070"/>
            </a:xfrm>
          </p:grpSpPr>
          <p:graphicFrame>
            <p:nvGraphicFramePr>
              <p:cNvPr id="91" name="图表 90">
                <a:extLst>
                  <a:ext uri="{FF2B5EF4-FFF2-40B4-BE49-F238E27FC236}">
                    <a16:creationId xmlns:a16="http://schemas.microsoft.com/office/drawing/2014/main" id="{98C8332D-F78E-0095-278B-2B59BA01090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05034965"/>
                  </p:ext>
                </p:extLst>
              </p:nvPr>
            </p:nvGraphicFramePr>
            <p:xfrm>
              <a:off x="11873369" y="900433"/>
              <a:ext cx="984204" cy="108923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005C28EE-0406-FCF9-F343-8954C45932E6}"/>
                  </a:ext>
                </a:extLst>
              </p:cNvPr>
              <p:cNvSpPr txBox="1"/>
              <p:nvPr/>
            </p:nvSpPr>
            <p:spPr>
              <a:xfrm rot="19648842">
                <a:off x="11950156" y="1931830"/>
                <a:ext cx="34003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defRPr/>
                </a:pP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zh-CN" altLang="en-US" sz="7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11E31E96-856A-3DFE-64CC-D91E1A97411A}"/>
                  </a:ext>
                </a:extLst>
              </p:cNvPr>
              <p:cNvSpPr txBox="1"/>
              <p:nvPr/>
            </p:nvSpPr>
            <p:spPr>
              <a:xfrm rot="19648842">
                <a:off x="11786673" y="2082781"/>
                <a:ext cx="86486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defRPr/>
                </a:pP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A </a:t>
                </a:r>
                <a:r>
                  <a:rPr lang="en-US" altLang="zh-CN" sz="700" kern="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NOate</a:t>
                </a:r>
                <a:endParaRPr lang="zh-CN" altLang="en-US" sz="7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文本框 215">
                <a:extLst>
                  <a:ext uri="{FF2B5EF4-FFF2-40B4-BE49-F238E27FC236}">
                    <a16:creationId xmlns:a16="http://schemas.microsoft.com/office/drawing/2014/main" id="{C12BA3A1-198A-923F-35D9-281FA5F7513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5400000" flipV="1">
                <a:off x="11538757" y="1383193"/>
                <a:ext cx="60512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宋体" charset="-122"/>
                  </a:defRPr>
                </a:lvl9pPr>
              </a:lstStyle>
              <a:p>
                <a:pPr algn="ctr">
                  <a:defRPr/>
                </a:pP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FE</a:t>
                </a:r>
                <a:r>
                  <a:rPr lang="en-US" altLang="zh-CN" sz="700" kern="0" dirty="0">
                    <a:solidFill>
                      <a:prstClr val="black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lang="zh-CN" altLang="en-US" sz="7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129">
                <a:extLst>
                  <a:ext uri="{FF2B5EF4-FFF2-40B4-BE49-F238E27FC236}">
                    <a16:creationId xmlns:a16="http://schemas.microsoft.com/office/drawing/2014/main" id="{9ADECA0E-524E-B043-6FD5-1611077319EE}"/>
                  </a:ext>
                </a:extLst>
              </p:cNvPr>
              <p:cNvSpPr txBox="1"/>
              <p:nvPr/>
            </p:nvSpPr>
            <p:spPr>
              <a:xfrm>
                <a:off x="12370225" y="1443526"/>
                <a:ext cx="372350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>
                  <a:defRPr/>
                </a:pPr>
                <a:r>
                  <a:rPr lang="en-US" altLang="zh-CN" sz="1400" kern="0" dirty="0">
                    <a:solidFill>
                      <a:prstClr val="black"/>
                    </a:solidFill>
                    <a:cs typeface="Arial" panose="020B0604020202020204" pitchFamily="34" charset="0"/>
                  </a:rPr>
                  <a:t>****</a:t>
                </a:r>
                <a:endParaRPr lang="zh-CN" altLang="en-US" sz="1400" kern="0" dirty="0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5CA56E7F-9AFD-C4B1-6BA3-1D0C7DE0B339}"/>
                </a:ext>
              </a:extLst>
            </p:cNvPr>
            <p:cNvSpPr txBox="1"/>
            <p:nvPr/>
          </p:nvSpPr>
          <p:spPr>
            <a:xfrm>
              <a:off x="5064138" y="2135484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658B7FF0-2500-1773-0F08-BF4426D13202}"/>
              </a:ext>
            </a:extLst>
          </p:cNvPr>
          <p:cNvSpPr txBox="1"/>
          <p:nvPr/>
        </p:nvSpPr>
        <p:spPr>
          <a:xfrm>
            <a:off x="323912" y="3829633"/>
            <a:ext cx="7091320" cy="20923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S1. Nitric oxide inhibits club cell proliferation in stromal-feed organoid cultures.</a:t>
            </a:r>
            <a:endParaRPr lang="zh-CN" altLang="zh-CN" sz="11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) Representative images of club cell organoid cultures (co-cultured with mouse lung fibroblast cell line (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Lg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) in the presence of 25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iethylamine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ONOate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DEA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ONOate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at day 8 after plating (n=5:5). Scale bar: 500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B, C) Diameter and CFEs of club cell colonies from the DEA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ONOate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group under the conditions described in (A) (n=5:5). (D) Numbers of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Lg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in control and nitric oxide (NO)-treated groups (n=6:6)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E, F, G) qPCR analysis of Fgf7 (E), Fgf10 (F), and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gf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G) expressions (relative to β-actin) of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Lg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cultured in a 100-mm petri dish for 72 h in the presence of DEA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ONOate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25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(n=6:6)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sults are represented by mean ± SD, ****p &lt; 0.0001; as determined by Student’s t-test.</a:t>
            </a:r>
            <a:endParaRPr lang="zh-CN" altLang="zh-CN" sz="11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2850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000" b="1" dirty="0">
            <a:solidFill>
              <a:srgbClr val="00B050"/>
            </a:solidFill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686</TotalTime>
  <Words>239</Words>
  <Application>Microsoft Office PowerPoint</Application>
  <PresentationFormat>自定义</PresentationFormat>
  <Paragraphs>3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rvel</dc:creator>
  <cp:lastModifiedBy>岳青</cp:lastModifiedBy>
  <cp:revision>1575</cp:revision>
  <cp:lastPrinted>2020-08-07T09:00:00Z</cp:lastPrinted>
  <dcterms:created xsi:type="dcterms:W3CDTF">2019-12-31T01:32:00Z</dcterms:created>
  <dcterms:modified xsi:type="dcterms:W3CDTF">2023-04-16T02:35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700</vt:lpwstr>
  </property>
  <property fmtid="{D5CDD505-2E9C-101B-9397-08002B2CF9AE}" pid="3" name="ICV">
    <vt:lpwstr>F6B2A8FAB1314C0CA40D9C07A9579253</vt:lpwstr>
  </property>
</Properties>
</file>